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09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1232AA4-412B-4D21-B09D-E69325352EF3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B904A0-F139-4112-9874-A800D69F27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74216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8F3E5FF-C2F8-4588-8145-E067E99C967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4282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B3048-2C1A-428D-92CD-7DD4F3D7E326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EB3EF-932F-4D75-8E7B-D04AEB2B6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42267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B3048-2C1A-428D-92CD-7DD4F3D7E326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EB3EF-932F-4D75-8E7B-D04AEB2B6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9722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B3048-2C1A-428D-92CD-7DD4F3D7E326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EB3EF-932F-4D75-8E7B-D04AEB2B6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63165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B3048-2C1A-428D-92CD-7DD4F3D7E326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EB3EF-932F-4D75-8E7B-D04AEB2B6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26746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B3048-2C1A-428D-92CD-7DD4F3D7E326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EB3EF-932F-4D75-8E7B-D04AEB2B6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62405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B3048-2C1A-428D-92CD-7DD4F3D7E326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EB3EF-932F-4D75-8E7B-D04AEB2B6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4388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B3048-2C1A-428D-92CD-7DD4F3D7E326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EB3EF-932F-4D75-8E7B-D04AEB2B6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82192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B3048-2C1A-428D-92CD-7DD4F3D7E326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EB3EF-932F-4D75-8E7B-D04AEB2B6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42382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B3048-2C1A-428D-92CD-7DD4F3D7E326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EB3EF-932F-4D75-8E7B-D04AEB2B6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91946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B3048-2C1A-428D-92CD-7DD4F3D7E326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EB3EF-932F-4D75-8E7B-D04AEB2B6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97703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B3048-2C1A-428D-92CD-7DD4F3D7E326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EB3EF-932F-4D75-8E7B-D04AEB2B6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350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9B3048-2C1A-428D-92CD-7DD4F3D7E326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4EB3EF-932F-4D75-8E7B-D04AEB2B6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40583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hyperlink" Target="http://www.genome.jp/kegg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1994261" y="4532305"/>
            <a:ext cx="15905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=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otein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ownregulated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 in biofilm</a:t>
            </a:r>
          </a:p>
        </p:txBody>
      </p:sp>
      <p:sp>
        <p:nvSpPr>
          <p:cNvPr id="8" name="Rectangle 7"/>
          <p:cNvSpPr/>
          <p:nvPr/>
        </p:nvSpPr>
        <p:spPr>
          <a:xfrm>
            <a:off x="1828649" y="4590010"/>
            <a:ext cx="228600" cy="152400"/>
          </a:xfrm>
          <a:prstGeom prst="rect">
            <a:avLst/>
          </a:prstGeom>
          <a:solidFill>
            <a:srgbClr val="92D05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/>
          <p:cNvSpPr/>
          <p:nvPr/>
        </p:nvSpPr>
        <p:spPr>
          <a:xfrm>
            <a:off x="1828649" y="4907445"/>
            <a:ext cx="228600" cy="152400"/>
          </a:xfrm>
          <a:prstGeom prst="rect">
            <a:avLst/>
          </a:prstGeom>
          <a:solidFill>
            <a:schemeClr val="bg1">
              <a:lumMod val="6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1994261" y="4880742"/>
            <a:ext cx="134684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= gene annotated in </a:t>
            </a:r>
            <a:endParaRPr lang="en-US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 H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influenzae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1573081" y="4532305"/>
            <a:ext cx="1950203" cy="74854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04675289"/>
              </p:ext>
            </p:extLst>
          </p:nvPr>
        </p:nvGraphicFramePr>
        <p:xfrm>
          <a:off x="5193169" y="805303"/>
          <a:ext cx="3894559" cy="148336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55937"/>
                <a:gridCol w="745588"/>
                <a:gridCol w="464234"/>
                <a:gridCol w="604911"/>
                <a:gridCol w="1223889"/>
              </a:tblGrid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</a:t>
                      </a:r>
                      <a:endParaRPr lang="en-US" sz="1000" u="none" strike="noStrike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ession 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cu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 numbe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film:Planktonic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atio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X87573.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THI065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ba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.2.1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X88019.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THI115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fkA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.1.1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X88128.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THI129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lB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.1.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742" y="805303"/>
            <a:ext cx="4848359" cy="3516897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3728735" y="5280852"/>
            <a:ext cx="5202065" cy="138499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14:  (A)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The genes encoding proteins involved in 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nergy metabolism that were found to be differentially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xpressed in the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iofilm:planktonic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samples were plotted on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KEGG pathways using the websit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  <a:hlinkClick r:id="rId4"/>
              </a:rPr>
              <a:t>http://www.genome.jp/kegg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  <a:hlinkClick r:id="rId4"/>
              </a:rPr>
              <a:t>/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</a:p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Information for the proteins plotted in the pentose phosphate pathway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at had differential expression in our study.</a:t>
            </a:r>
          </a:p>
          <a:p>
            <a:endParaRPr 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03181" y="348127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293350" y="348127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19090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6</Words>
  <Application>Microsoft Office PowerPoint</Application>
  <PresentationFormat>On-screen Show (4:3)</PresentationFormat>
  <Paragraphs>3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borah Post</dc:creator>
  <cp:lastModifiedBy>Deborah Post</cp:lastModifiedBy>
  <cp:revision>1</cp:revision>
  <dcterms:created xsi:type="dcterms:W3CDTF">2014-11-18T00:47:17Z</dcterms:created>
  <dcterms:modified xsi:type="dcterms:W3CDTF">2014-11-18T00:47:33Z</dcterms:modified>
</cp:coreProperties>
</file>